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2" r:id="rId2"/>
  </p:sldIdLst>
  <p:sldSz cx="9144000" cy="6858000" type="screen4x3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-1458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AE7328C-E87A-4599-8145-1245DF1B2469}" type="datetimeFigureOut">
              <a:rPr lang="en-GB" smtClean="0"/>
              <a:t>03/10/201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4C944DE-331C-4087-ACBF-E78669D17B4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96766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8856E-5651-46F3-A3DE-FF936D600928}" type="datetimeFigureOut">
              <a:rPr lang="en-GB" smtClean="0"/>
              <a:t>03/10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870A9-D7E9-4180-9BE9-A9621E780D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69592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8856E-5651-46F3-A3DE-FF936D600928}" type="datetimeFigureOut">
              <a:rPr lang="en-GB" smtClean="0"/>
              <a:t>03/10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870A9-D7E9-4180-9BE9-A9621E780D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88880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8856E-5651-46F3-A3DE-FF936D600928}" type="datetimeFigureOut">
              <a:rPr lang="en-GB" smtClean="0"/>
              <a:t>03/10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870A9-D7E9-4180-9BE9-A9621E780D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83336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8856E-5651-46F3-A3DE-FF936D600928}" type="datetimeFigureOut">
              <a:rPr lang="en-GB" smtClean="0"/>
              <a:t>03/10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870A9-D7E9-4180-9BE9-A9621E780D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682273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8856E-5651-46F3-A3DE-FF936D600928}" type="datetimeFigureOut">
              <a:rPr lang="en-GB" smtClean="0"/>
              <a:t>03/10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870A9-D7E9-4180-9BE9-A9621E780D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31764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8856E-5651-46F3-A3DE-FF936D600928}" type="datetimeFigureOut">
              <a:rPr lang="en-GB" smtClean="0"/>
              <a:t>03/10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870A9-D7E9-4180-9BE9-A9621E780D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08461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8856E-5651-46F3-A3DE-FF936D600928}" type="datetimeFigureOut">
              <a:rPr lang="en-GB" smtClean="0"/>
              <a:t>03/10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870A9-D7E9-4180-9BE9-A9621E780D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63376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8856E-5651-46F3-A3DE-FF936D600928}" type="datetimeFigureOut">
              <a:rPr lang="en-GB" smtClean="0"/>
              <a:t>03/10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870A9-D7E9-4180-9BE9-A9621E780D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32520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8856E-5651-46F3-A3DE-FF936D600928}" type="datetimeFigureOut">
              <a:rPr lang="en-GB" smtClean="0"/>
              <a:t>03/10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870A9-D7E9-4180-9BE9-A9621E780D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74314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8856E-5651-46F3-A3DE-FF936D600928}" type="datetimeFigureOut">
              <a:rPr lang="en-GB" smtClean="0"/>
              <a:t>03/10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870A9-D7E9-4180-9BE9-A9621E780D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64567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8856E-5651-46F3-A3DE-FF936D600928}" type="datetimeFigureOut">
              <a:rPr lang="en-GB" smtClean="0"/>
              <a:t>03/10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870A9-D7E9-4180-9BE9-A9621E780D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70035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78856E-5651-46F3-A3DE-FF936D600928}" type="datetimeFigureOut">
              <a:rPr lang="en-GB" smtClean="0"/>
              <a:t>03/10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6870A9-D7E9-4180-9BE9-A9621E780D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91434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467546" y="242496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A</a:t>
            </a:r>
            <a:endParaRPr lang="en-GB" sz="24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467545" y="2385748"/>
            <a:ext cx="42196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/>
              <a:t>B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67544" y="4545988"/>
            <a:ext cx="42196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/>
              <a:t>C</a:t>
            </a:r>
          </a:p>
        </p:txBody>
      </p:sp>
      <p:pic>
        <p:nvPicPr>
          <p:cNvPr id="1029" name="e4af5c7b-4b62-47c5-ae24-6f43a78ed3e4" descr="515DA31A-D836-4F8A-9C46-2EDA43C31F0C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27619" y="4545988"/>
            <a:ext cx="2880320" cy="2051364"/>
          </a:xfrm>
          <a:prstGeom prst="rect">
            <a:avLst/>
          </a:prstGeom>
          <a:noFill/>
          <a:ln w="1905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b8524b25-df41-477c-b017-c238ecdce8b5" descr="4431356F-F861-4B40-9135-23EA07C8D586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27618" y="211526"/>
            <a:ext cx="2899951" cy="2065346"/>
          </a:xfrm>
          <a:prstGeom prst="rect">
            <a:avLst/>
          </a:prstGeom>
          <a:noFill/>
          <a:ln w="1905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1" name="32db6444-863c-435f-8912-a5a2ba730dec" descr="B4F7E114-12A1-482B-B1A6-DDF981EE2AC5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27619" y="2402736"/>
            <a:ext cx="2880320" cy="2034376"/>
          </a:xfrm>
          <a:prstGeom prst="rect">
            <a:avLst/>
          </a:prstGeom>
          <a:noFill/>
          <a:ln w="1905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Rectangle 1"/>
          <p:cNvSpPr/>
          <p:nvPr/>
        </p:nvSpPr>
        <p:spPr>
          <a:xfrm>
            <a:off x="4355976" y="140439"/>
            <a:ext cx="4608512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Differential interference contrast micrographs of samples from (A) the dorsal surface of the tongue, (B) saliva and (C) the probiotic yoghurt drink. The bar indicates a length of 10 µm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1847804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405</TotalTime>
  <Words>42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TN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mco Kort</dc:creator>
  <cp:lastModifiedBy>Remco Kort</cp:lastModifiedBy>
  <cp:revision>91</cp:revision>
  <dcterms:created xsi:type="dcterms:W3CDTF">2014-04-01T09:35:37Z</dcterms:created>
  <dcterms:modified xsi:type="dcterms:W3CDTF">2014-10-03T10:28:3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PresentationDate">
    <vt:lpwstr>7-7-2014 23:13:48</vt:lpwstr>
  </property>
</Properties>
</file>